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21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276" r:id="rId26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5.xml"/><Relationship Id="rId22" Type="http://schemas.openxmlformats.org/officeDocument/2006/relationships/slide" Target="slides/slide17.xml"/><Relationship Id="rId21" Type="http://schemas.openxmlformats.org/officeDocument/2006/relationships/slide" Target="slides/slide16.xml"/><Relationship Id="rId24" Type="http://schemas.openxmlformats.org/officeDocument/2006/relationships/slide" Target="slides/slide19.xml"/><Relationship Id="rId23" Type="http://schemas.openxmlformats.org/officeDocument/2006/relationships/slide" Target="slides/slide18.xml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26" Type="http://schemas.openxmlformats.org/officeDocument/2006/relationships/slide" Target="slides/slide21.xml"/><Relationship Id="rId25" Type="http://schemas.openxmlformats.org/officeDocument/2006/relationships/slide" Target="slides/slide20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19" Type="http://schemas.openxmlformats.org/officeDocument/2006/relationships/slide" Target="slides/slide14.xml"/><Relationship Id="rId18" Type="http://schemas.openxmlformats.org/officeDocument/2006/relationships/slide" Target="slides/slide1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0" name="Shape 2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Google Shape;251;g363b65b7cd5_0_21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52" name="Google Shape;252;g363b65b7cd5_0_21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1" name="Shape 2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Google Shape;272;g363b65b7cd5_0_22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3" name="Google Shape;273;g363b65b7cd5_0_22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9" name="Shape 2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Google Shape;300;g372e51ad622_0_1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01" name="Google Shape;301;g372e51ad622_0_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8" name="Shape 3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Google Shape;319;g363b65b7cd5_0_24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20" name="Google Shape;320;g363b65b7cd5_0_24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44" name="Shape 3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Google Shape;345;g363b65b7cd5_0_25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46" name="Google Shape;346;g363b65b7cd5_0_25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7" name="Shape 3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Google Shape;368;g363b65b7cd5_0_41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9" name="Google Shape;369;g363b65b7cd5_0_41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96" name="Shape 3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7" name="Google Shape;397;g363b65b7cd5_0_42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98" name="Google Shape;398;g363b65b7cd5_0_42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22" name="Shape 4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Google Shape;423;g363b65b7cd5_0_43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24" name="Google Shape;424;g363b65b7cd5_0_43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45" name="Shape 4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Google Shape;446;g372ddccea68_0_1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47" name="Google Shape;447;g372ddccea68_0_1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62" name="Shape 4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Google Shape;463;g372ddccea68_0_2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64" name="Google Shape;464;g372ddccea68_0_2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3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g363b65b7cd5_0_1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5" name="Google Shape;75;g363b65b7cd5_0_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82" name="Shape 4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" name="Google Shape;483;g372ddccea68_0_3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84" name="Google Shape;484;g372ddccea68_0_3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2" name="Shape 5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3" name="Google Shape;503;g372ddccea68_0_4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04" name="Google Shape;504;g372ddccea68_0_4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7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363b65b7cd5_0_1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9" name="Google Shape;99;g363b65b7cd5_0_1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363b65b7cd5_0_1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363b65b7cd5_0_1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5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g363b65b7cd5_0_16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7" name="Google Shape;147;g363b65b7cd5_0_16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0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g363b65b7cd5_0_17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2" name="Google Shape;172;g363b65b7cd5_0_17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9" name="Shape 1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Google Shape;190;g363b65b7cd5_0_18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1" name="Google Shape;191;g363b65b7cd5_0_18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1" name="Shape 2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Google Shape;212;g363b65b7cd5_0_19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13" name="Google Shape;213;g363b65b7cd5_0_19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2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g363b65b7cd5_0_20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34" name="Google Shape;234;g363b65b7cd5_0_20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8.png"/><Relationship Id="rId4" Type="http://schemas.openxmlformats.org/officeDocument/2006/relationships/image" Target="../media/image12.png"/><Relationship Id="rId5" Type="http://schemas.openxmlformats.org/officeDocument/2006/relationships/image" Target="../media/image20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27.png"/><Relationship Id="rId4" Type="http://schemas.openxmlformats.org/officeDocument/2006/relationships/image" Target="../media/image10.png"/><Relationship Id="rId5" Type="http://schemas.openxmlformats.org/officeDocument/2006/relationships/image" Target="../media/image14.png"/><Relationship Id="rId6" Type="http://schemas.openxmlformats.org/officeDocument/2006/relationships/image" Target="../media/image18.png"/><Relationship Id="rId7" Type="http://schemas.openxmlformats.org/officeDocument/2006/relationships/image" Target="../media/image39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24.png"/><Relationship Id="rId4" Type="http://schemas.openxmlformats.org/officeDocument/2006/relationships/image" Target="../media/image52.png"/><Relationship Id="rId5" Type="http://schemas.openxmlformats.org/officeDocument/2006/relationships/image" Target="../media/image26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30.png"/><Relationship Id="rId4" Type="http://schemas.openxmlformats.org/officeDocument/2006/relationships/image" Target="../media/image34.png"/><Relationship Id="rId5" Type="http://schemas.openxmlformats.org/officeDocument/2006/relationships/image" Target="../media/image47.png"/><Relationship Id="rId6" Type="http://schemas.openxmlformats.org/officeDocument/2006/relationships/image" Target="../media/image22.png"/><Relationship Id="rId7" Type="http://schemas.openxmlformats.org/officeDocument/2006/relationships/image" Target="../media/image28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46.png"/><Relationship Id="rId4" Type="http://schemas.openxmlformats.org/officeDocument/2006/relationships/image" Target="../media/image49.png"/><Relationship Id="rId5" Type="http://schemas.openxmlformats.org/officeDocument/2006/relationships/image" Target="../media/image36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32.png"/><Relationship Id="rId4" Type="http://schemas.openxmlformats.org/officeDocument/2006/relationships/image" Target="../media/image38.png"/><Relationship Id="rId5" Type="http://schemas.openxmlformats.org/officeDocument/2006/relationships/image" Target="../media/image45.png"/><Relationship Id="rId6" Type="http://schemas.openxmlformats.org/officeDocument/2006/relationships/image" Target="../media/image42.png"/><Relationship Id="rId7" Type="http://schemas.openxmlformats.org/officeDocument/2006/relationships/image" Target="../media/image35.png"/><Relationship Id="rId8" Type="http://schemas.openxmlformats.org/officeDocument/2006/relationships/image" Target="../media/image60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59.png"/><Relationship Id="rId4" Type="http://schemas.openxmlformats.org/officeDocument/2006/relationships/image" Target="../media/image48.png"/><Relationship Id="rId5" Type="http://schemas.openxmlformats.org/officeDocument/2006/relationships/image" Target="../media/image37.png"/><Relationship Id="rId6" Type="http://schemas.openxmlformats.org/officeDocument/2006/relationships/image" Target="../media/image53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58.png"/><Relationship Id="rId4" Type="http://schemas.openxmlformats.org/officeDocument/2006/relationships/image" Target="../media/image26.png"/><Relationship Id="rId5" Type="http://schemas.openxmlformats.org/officeDocument/2006/relationships/image" Target="../media/image51.png"/><Relationship Id="rId6" Type="http://schemas.openxmlformats.org/officeDocument/2006/relationships/image" Target="../media/image59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40.png"/><Relationship Id="rId4" Type="http://schemas.openxmlformats.org/officeDocument/2006/relationships/image" Target="../media/image43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58.png"/><Relationship Id="rId4" Type="http://schemas.openxmlformats.org/officeDocument/2006/relationships/image" Target="../media/image50.png"/><Relationship Id="rId5" Type="http://schemas.openxmlformats.org/officeDocument/2006/relationships/image" Target="../media/image54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9.png"/><Relationship Id="rId4" Type="http://schemas.openxmlformats.org/officeDocument/2006/relationships/image" Target="../media/image13.png"/><Relationship Id="rId5" Type="http://schemas.openxmlformats.org/officeDocument/2006/relationships/image" Target="../media/image21.png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55.png"/><Relationship Id="rId4" Type="http://schemas.openxmlformats.org/officeDocument/2006/relationships/image" Target="../media/image56.png"/><Relationship Id="rId5" Type="http://schemas.openxmlformats.org/officeDocument/2006/relationships/image" Target="../media/image37.png"/></Relationships>
</file>

<file path=ppt/slides/_rels/slide2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44.png"/><Relationship Id="rId4" Type="http://schemas.openxmlformats.org/officeDocument/2006/relationships/image" Target="../media/image61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7.png"/><Relationship Id="rId4" Type="http://schemas.openxmlformats.org/officeDocument/2006/relationships/image" Target="../media/image5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7.png"/><Relationship Id="rId4" Type="http://schemas.openxmlformats.org/officeDocument/2006/relationships/image" Target="../media/image29.png"/><Relationship Id="rId5" Type="http://schemas.openxmlformats.org/officeDocument/2006/relationships/image" Target="../media/image33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31.png"/><Relationship Id="rId4" Type="http://schemas.openxmlformats.org/officeDocument/2006/relationships/image" Target="../media/image1.png"/><Relationship Id="rId5" Type="http://schemas.openxmlformats.org/officeDocument/2006/relationships/image" Target="../media/image6.png"/><Relationship Id="rId6" Type="http://schemas.openxmlformats.org/officeDocument/2006/relationships/image" Target="../media/image16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31.png"/><Relationship Id="rId4" Type="http://schemas.openxmlformats.org/officeDocument/2006/relationships/image" Target="../media/image41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4.png"/><Relationship Id="rId4" Type="http://schemas.openxmlformats.org/officeDocument/2006/relationships/image" Target="../media/image15.png"/><Relationship Id="rId5" Type="http://schemas.openxmlformats.org/officeDocument/2006/relationships/image" Target="../media/image9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4.png"/><Relationship Id="rId4" Type="http://schemas.openxmlformats.org/officeDocument/2006/relationships/image" Target="../media/image11.png"/><Relationship Id="rId5" Type="http://schemas.openxmlformats.org/officeDocument/2006/relationships/image" Target="../media/image25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 title="HGD1_TFP-F_17_06_2024_PL1_RED_NI_povtor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75375"/>
            <a:ext cx="8839204" cy="418654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/>
          <p:nvPr/>
        </p:nvSpPr>
        <p:spPr>
          <a:xfrm rot="-5400000">
            <a:off x="4228775" y="-2156750"/>
            <a:ext cx="109500" cy="66588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6" name="Google Shape;56;p13"/>
          <p:cNvSpPr/>
          <p:nvPr/>
        </p:nvSpPr>
        <p:spPr>
          <a:xfrm rot="-5400000">
            <a:off x="7926875" y="799025"/>
            <a:ext cx="109500" cy="7374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7" name="Google Shape;57;p13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p13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9" name="Google Shape;59;p13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60" name="Google Shape;60;p13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1" name="Google Shape;61;p13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</a:t>
            </a:r>
            <a:r>
              <a:rPr b="1" lang="ru" sz="1200">
                <a:solidFill>
                  <a:schemeClr val="dk2"/>
                </a:solidFill>
              </a:rPr>
              <a:t>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2" name="Google Shape;62;p13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3458525" y="1227400"/>
            <a:ext cx="16500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HGD 5’-UTR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7372325" y="1227400"/>
            <a:ext cx="1218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65" name="Google Shape;65;p13" title="HGD2_TFP-F_30_05_2024_PL2_GREEN_NI_NI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541500"/>
            <a:ext cx="8839197" cy="737419"/>
          </a:xfrm>
          <a:prstGeom prst="rect">
            <a:avLst/>
          </a:prstGeom>
          <a:noFill/>
          <a:ln>
            <a:noFill/>
          </a:ln>
        </p:spPr>
      </p:pic>
      <p:sp>
        <p:nvSpPr>
          <p:cNvPr id="66" name="Google Shape;66;p13"/>
          <p:cNvSpPr/>
          <p:nvPr/>
        </p:nvSpPr>
        <p:spPr>
          <a:xfrm rot="-5400000">
            <a:off x="4519100" y="-1043150"/>
            <a:ext cx="109500" cy="65445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67" name="Google Shape;67;p13"/>
          <p:cNvSpPr txBox="1"/>
          <p:nvPr/>
        </p:nvSpPr>
        <p:spPr>
          <a:xfrm>
            <a:off x="3974250" y="2283850"/>
            <a:ext cx="1195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2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68" name="Google Shape;68;p13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s 1, 2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69" name="Google Shape;69;p13"/>
          <p:cNvSpPr txBox="1"/>
          <p:nvPr/>
        </p:nvSpPr>
        <p:spPr>
          <a:xfrm>
            <a:off x="152400" y="6088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70" name="Google Shape;70;p13"/>
          <p:cNvSpPr txBox="1"/>
          <p:nvPr/>
        </p:nvSpPr>
        <p:spPr>
          <a:xfrm>
            <a:off x="152400" y="1379808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2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71" name="Google Shape;71;p13"/>
          <p:cNvSpPr/>
          <p:nvPr/>
        </p:nvSpPr>
        <p:spPr>
          <a:xfrm>
            <a:off x="58911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C6F6F1"/>
          </a:solidFill>
          <a:ln cap="flat" cmpd="sng" w="9525">
            <a:solidFill>
              <a:srgbClr val="C6F6F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72" name="Google Shape;72;p13"/>
          <p:cNvSpPr txBox="1"/>
          <p:nvPr/>
        </p:nvSpPr>
        <p:spPr>
          <a:xfrm>
            <a:off x="60528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HGD 5’-UTR</a:t>
            </a:r>
            <a:endParaRPr b="1" sz="12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53" name="Shape 2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Google Shape;254;p22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5" name="Google Shape;255;p22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6" name="Google Shape;256;p22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57" name="Google Shape;257;p22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58" name="Google Shape;258;p22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59" name="Google Shape;259;p22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60" name="Google Shape;260;p22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8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261" name="Google Shape;261;p22" title="HGD8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2" cy="722157"/>
          </a:xfrm>
          <a:prstGeom prst="rect">
            <a:avLst/>
          </a:prstGeom>
          <a:noFill/>
          <a:ln>
            <a:noFill/>
          </a:ln>
        </p:spPr>
      </p:pic>
      <p:sp>
        <p:nvSpPr>
          <p:cNvPr id="262" name="Google Shape;262;p22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8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63" name="Google Shape;263;p22"/>
          <p:cNvSpPr/>
          <p:nvPr/>
        </p:nvSpPr>
        <p:spPr>
          <a:xfrm rot="-5400000">
            <a:off x="4518275" y="-1884850"/>
            <a:ext cx="109500" cy="6717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64" name="Google Shape;264;p22"/>
          <p:cNvSpPr txBox="1"/>
          <p:nvPr/>
        </p:nvSpPr>
        <p:spPr>
          <a:xfrm>
            <a:off x="3962250" y="15285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8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65" name="Google Shape;265;p22" title="HGD27_1_TFP-F_17_06_2024_PL1_RED_NI_povtor_NI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3425" y="2241000"/>
            <a:ext cx="8839199" cy="691283"/>
          </a:xfrm>
          <a:prstGeom prst="rect">
            <a:avLst/>
          </a:prstGeom>
          <a:noFill/>
          <a:ln>
            <a:noFill/>
          </a:ln>
        </p:spPr>
      </p:pic>
      <p:sp>
        <p:nvSpPr>
          <p:cNvPr id="266" name="Google Shape;266;p22"/>
          <p:cNvSpPr/>
          <p:nvPr/>
        </p:nvSpPr>
        <p:spPr>
          <a:xfrm rot="-5400000">
            <a:off x="4519300" y="-443300"/>
            <a:ext cx="109500" cy="6717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67" name="Google Shape;267;p22"/>
          <p:cNvSpPr txBox="1"/>
          <p:nvPr/>
        </p:nvSpPr>
        <p:spPr>
          <a:xfrm>
            <a:off x="3962250" y="29701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8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68" name="Google Shape;268;p22" title="HGD27_2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3431" y="3246375"/>
            <a:ext cx="2094235" cy="722150"/>
          </a:xfrm>
          <a:prstGeom prst="rect">
            <a:avLst/>
          </a:prstGeom>
          <a:noFill/>
          <a:ln>
            <a:noFill/>
          </a:ln>
        </p:spPr>
      </p:pic>
      <p:sp>
        <p:nvSpPr>
          <p:cNvPr id="269" name="Google Shape;269;p22"/>
          <p:cNvSpPr txBox="1"/>
          <p:nvPr/>
        </p:nvSpPr>
        <p:spPr>
          <a:xfrm>
            <a:off x="591813" y="39920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8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270" name="Google Shape;270;p22"/>
          <p:cNvSpPr txBox="1"/>
          <p:nvPr/>
        </p:nvSpPr>
        <p:spPr>
          <a:xfrm>
            <a:off x="153425" y="20885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549G&gt;T (p.Gln183His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4" name="Shape 2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Google Shape;275;p23"/>
          <p:cNvSpPr/>
          <p:nvPr/>
        </p:nvSpPr>
        <p:spPr>
          <a:xfrm>
            <a:off x="1052125" y="838100"/>
            <a:ext cx="7074600" cy="424500"/>
          </a:xfrm>
          <a:prstGeom prst="rect">
            <a:avLst/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pic>
        <p:nvPicPr>
          <p:cNvPr id="276" name="Google Shape;276;p23" title="HGD9_1_GFP-R_17_06_2024_PL1_RED_NI_povtor_NI_Std_1_1_shorter_copy.png"/>
          <p:cNvPicPr preferRelativeResize="0"/>
          <p:nvPr/>
        </p:nvPicPr>
        <p:blipFill rotWithShape="1">
          <a:blip r:embed="rId3">
            <a:alphaModFix/>
          </a:blip>
          <a:srcRect b="0" l="0" r="74910" t="0"/>
          <a:stretch/>
        </p:blipFill>
        <p:spPr>
          <a:xfrm>
            <a:off x="150725" y="794425"/>
            <a:ext cx="2735826" cy="569700"/>
          </a:xfrm>
          <a:prstGeom prst="rect">
            <a:avLst/>
          </a:prstGeom>
          <a:noFill/>
          <a:ln>
            <a:noFill/>
          </a:ln>
        </p:spPr>
      </p:pic>
      <p:sp>
        <p:nvSpPr>
          <p:cNvPr id="277" name="Google Shape;277;p23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78" name="Google Shape;278;p23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79" name="Google Shape;279;p23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80" name="Google Shape;280;p23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81" name="Google Shape;281;p23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82" name="Google Shape;282;p23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83" name="Google Shape;283;p23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9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84" name="Google Shape;284;p23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9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85" name="Google Shape;285;p23"/>
          <p:cNvSpPr/>
          <p:nvPr/>
        </p:nvSpPr>
        <p:spPr>
          <a:xfrm rot="-5400000">
            <a:off x="4529900" y="-2196000"/>
            <a:ext cx="109500" cy="7092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86" name="Google Shape;286;p23"/>
          <p:cNvSpPr txBox="1"/>
          <p:nvPr/>
        </p:nvSpPr>
        <p:spPr>
          <a:xfrm>
            <a:off x="3792350" y="1405050"/>
            <a:ext cx="1584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87" name="Google Shape;287;p23" title="HGD9_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22850" y="1622275"/>
            <a:ext cx="1667392" cy="569725"/>
          </a:xfrm>
          <a:prstGeom prst="rect">
            <a:avLst/>
          </a:prstGeom>
          <a:noFill/>
          <a:ln>
            <a:noFill/>
          </a:ln>
        </p:spPr>
      </p:pic>
      <p:sp>
        <p:nvSpPr>
          <p:cNvPr id="288" name="Google Shape;288;p23"/>
          <p:cNvSpPr txBox="1"/>
          <p:nvPr/>
        </p:nvSpPr>
        <p:spPr>
          <a:xfrm>
            <a:off x="359438" y="22140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89" name="Google Shape;289;p23" title="HGD28_1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937600"/>
            <a:ext cx="8839204" cy="569714"/>
          </a:xfrm>
          <a:prstGeom prst="rect">
            <a:avLst/>
          </a:prstGeom>
          <a:noFill/>
          <a:ln>
            <a:noFill/>
          </a:ln>
        </p:spPr>
      </p:pic>
      <p:sp>
        <p:nvSpPr>
          <p:cNvPr id="290" name="Google Shape;290;p23"/>
          <p:cNvSpPr txBox="1"/>
          <p:nvPr/>
        </p:nvSpPr>
        <p:spPr>
          <a:xfrm>
            <a:off x="152400" y="27758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612T&gt;C (p.Tyr204=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91" name="Google Shape;291;p23"/>
          <p:cNvSpPr/>
          <p:nvPr/>
        </p:nvSpPr>
        <p:spPr>
          <a:xfrm rot="-5400000">
            <a:off x="4524950" y="-37050"/>
            <a:ext cx="109500" cy="7082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92" name="Google Shape;292;p23"/>
          <p:cNvSpPr txBox="1"/>
          <p:nvPr/>
        </p:nvSpPr>
        <p:spPr>
          <a:xfrm>
            <a:off x="3792350" y="3559050"/>
            <a:ext cx="1584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93" name="Google Shape;293;p23" title="HGD28_2_TFP-F_03_06_2024_Vika_AG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73550" y="3813500"/>
            <a:ext cx="1652200" cy="569725"/>
          </a:xfrm>
          <a:prstGeom prst="rect">
            <a:avLst/>
          </a:prstGeom>
          <a:noFill/>
          <a:ln>
            <a:noFill/>
          </a:ln>
        </p:spPr>
      </p:pic>
      <p:sp>
        <p:nvSpPr>
          <p:cNvPr id="294" name="Google Shape;294;p23"/>
          <p:cNvSpPr txBox="1"/>
          <p:nvPr/>
        </p:nvSpPr>
        <p:spPr>
          <a:xfrm>
            <a:off x="389888" y="43832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95" name="Google Shape;295;p23" title="HGD9_1_TFP-F_17_06_2024_PL1_RED_NI_povtor_NI_Std_1_1_shorter_copy.png"/>
          <p:cNvPicPr preferRelativeResize="0"/>
          <p:nvPr/>
        </p:nvPicPr>
        <p:blipFill rotWithShape="1">
          <a:blip r:embed="rId7">
            <a:alphaModFix/>
          </a:blip>
          <a:srcRect b="0" l="33257" r="0" t="0"/>
          <a:stretch/>
        </p:blipFill>
        <p:spPr>
          <a:xfrm>
            <a:off x="2886575" y="794412"/>
            <a:ext cx="6131999" cy="569725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296" name="Google Shape;296;p23"/>
          <p:cNvCxnSpPr/>
          <p:nvPr/>
        </p:nvCxnSpPr>
        <p:spPr>
          <a:xfrm>
            <a:off x="2886575" y="679700"/>
            <a:ext cx="0" cy="5829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dash"/>
            <a:round/>
            <a:headEnd len="med" w="med" type="none"/>
            <a:tailEnd len="med" w="med" type="none"/>
          </a:ln>
        </p:spPr>
      </p:cxnSp>
      <p:sp>
        <p:nvSpPr>
          <p:cNvPr id="297" name="Google Shape;297;p23"/>
          <p:cNvSpPr txBox="1"/>
          <p:nvPr/>
        </p:nvSpPr>
        <p:spPr>
          <a:xfrm>
            <a:off x="2886600" y="679700"/>
            <a:ext cx="9900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800">
                <a:solidFill>
                  <a:schemeClr val="dk2"/>
                </a:solidFill>
              </a:rPr>
              <a:t>Forward primer</a:t>
            </a:r>
            <a:endParaRPr sz="800">
              <a:solidFill>
                <a:schemeClr val="dk2"/>
              </a:solidFill>
            </a:endParaRPr>
          </a:p>
        </p:txBody>
      </p:sp>
      <p:sp>
        <p:nvSpPr>
          <p:cNvPr id="298" name="Google Shape;298;p23"/>
          <p:cNvSpPr txBox="1"/>
          <p:nvPr/>
        </p:nvSpPr>
        <p:spPr>
          <a:xfrm>
            <a:off x="1896575" y="679700"/>
            <a:ext cx="9900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lang="ru" sz="800">
                <a:solidFill>
                  <a:schemeClr val="dk2"/>
                </a:solidFill>
              </a:rPr>
              <a:t>Reverse</a:t>
            </a:r>
            <a:r>
              <a:rPr lang="ru" sz="800">
                <a:solidFill>
                  <a:schemeClr val="dk2"/>
                </a:solidFill>
              </a:rPr>
              <a:t> primer</a:t>
            </a:r>
            <a:endParaRPr sz="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02" name="Shape 3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Google Shape;303;p24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04" name="Google Shape;304;p24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05" name="Google Shape;305;p24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06" name="Google Shape;306;p24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07" name="Google Shape;307;p24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08" name="Google Shape;308;p24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09" name="Google Shape;309;p24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9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310" name="Google Shape;310;p24" title="HGD29_1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604242"/>
          </a:xfrm>
          <a:prstGeom prst="rect">
            <a:avLst/>
          </a:prstGeom>
          <a:noFill/>
          <a:ln>
            <a:noFill/>
          </a:ln>
        </p:spPr>
      </p:pic>
      <p:sp>
        <p:nvSpPr>
          <p:cNvPr id="311" name="Google Shape;311;p24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624T&gt;C (p.Phe208=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312" name="Google Shape;312;p24"/>
          <p:cNvSpPr/>
          <p:nvPr/>
        </p:nvSpPr>
        <p:spPr>
          <a:xfrm rot="-5400000">
            <a:off x="4529900" y="-2196000"/>
            <a:ext cx="109500" cy="7092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13" name="Google Shape;313;p24"/>
          <p:cNvSpPr txBox="1"/>
          <p:nvPr/>
        </p:nvSpPr>
        <p:spPr>
          <a:xfrm>
            <a:off x="3792350" y="1405050"/>
            <a:ext cx="1584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14" name="Google Shape;314;p24"/>
          <p:cNvSpPr txBox="1"/>
          <p:nvPr/>
        </p:nvSpPr>
        <p:spPr>
          <a:xfrm>
            <a:off x="414713" y="2238888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9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15" name="Google Shape;315;p24" title="HGD30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388" y="2949463"/>
            <a:ext cx="1744197" cy="6042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6" name="Google Shape;316;p24" title="HGD36_2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60438" y="1634663"/>
            <a:ext cx="1728081" cy="604225"/>
          </a:xfrm>
          <a:prstGeom prst="rect">
            <a:avLst/>
          </a:prstGeom>
          <a:noFill/>
          <a:ln>
            <a:noFill/>
          </a:ln>
        </p:spPr>
      </p:pic>
      <p:sp>
        <p:nvSpPr>
          <p:cNvPr id="317" name="Google Shape;317;p24"/>
          <p:cNvSpPr txBox="1"/>
          <p:nvPr/>
        </p:nvSpPr>
        <p:spPr>
          <a:xfrm>
            <a:off x="152388" y="2787758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649G&gt;T (p.Gly217Trp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2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25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23" name="Google Shape;323;p25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24" name="Google Shape;324;p25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25" name="Google Shape;325;p25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26" name="Google Shape;326;p25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27" name="Google Shape;327;p25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28" name="Google Shape;328;p25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0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329" name="Google Shape;329;p25" title="HGD10_1_TFP-F_25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466130"/>
          </a:xfrm>
          <a:prstGeom prst="rect">
            <a:avLst/>
          </a:prstGeom>
          <a:noFill/>
          <a:ln>
            <a:noFill/>
          </a:ln>
        </p:spPr>
      </p:pic>
      <p:sp>
        <p:nvSpPr>
          <p:cNvPr id="330" name="Google Shape;330;p25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0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331" name="Google Shape;331;p25"/>
          <p:cNvSpPr/>
          <p:nvPr/>
        </p:nvSpPr>
        <p:spPr>
          <a:xfrm rot="-5400000">
            <a:off x="4536100" y="-2433450"/>
            <a:ext cx="109500" cy="7348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32" name="Google Shape;332;p25"/>
          <p:cNvSpPr txBox="1"/>
          <p:nvPr/>
        </p:nvSpPr>
        <p:spPr>
          <a:xfrm>
            <a:off x="3943000" y="12954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0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33" name="Google Shape;333;p25" title="HGD10_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398" y="1498975"/>
            <a:ext cx="1608300" cy="554589"/>
          </a:xfrm>
          <a:prstGeom prst="rect">
            <a:avLst/>
          </a:prstGeom>
          <a:noFill/>
          <a:ln>
            <a:noFill/>
          </a:ln>
        </p:spPr>
      </p:pic>
      <p:sp>
        <p:nvSpPr>
          <p:cNvPr id="334" name="Google Shape;334;p25"/>
          <p:cNvSpPr txBox="1"/>
          <p:nvPr/>
        </p:nvSpPr>
        <p:spPr>
          <a:xfrm>
            <a:off x="327538" y="20758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0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35" name="Google Shape;335;p25" title="HGD31_1-TFP-F_10_06_2024_PL1_RED_VIKA_povtor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561513"/>
            <a:ext cx="8839204" cy="479078"/>
          </a:xfrm>
          <a:prstGeom prst="rect">
            <a:avLst/>
          </a:prstGeom>
          <a:noFill/>
          <a:ln>
            <a:noFill/>
          </a:ln>
        </p:spPr>
      </p:pic>
      <p:sp>
        <p:nvSpPr>
          <p:cNvPr id="336" name="Google Shape;336;p25"/>
          <p:cNvSpPr/>
          <p:nvPr/>
        </p:nvSpPr>
        <p:spPr>
          <a:xfrm rot="-5400000">
            <a:off x="4536100" y="-635512"/>
            <a:ext cx="109500" cy="7348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37" name="Google Shape;337;p25"/>
          <p:cNvSpPr txBox="1"/>
          <p:nvPr/>
        </p:nvSpPr>
        <p:spPr>
          <a:xfrm>
            <a:off x="3943000" y="30933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0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38" name="Google Shape;338;p25"/>
          <p:cNvSpPr txBox="1"/>
          <p:nvPr/>
        </p:nvSpPr>
        <p:spPr>
          <a:xfrm>
            <a:off x="152400" y="2399808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714A&gt;G (p.Gln238=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339" name="Google Shape;339;p25" title="HGD31_2_TFP-F_03_06_2024_Vika_AG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6075" y="3255038"/>
            <a:ext cx="1600945" cy="554600"/>
          </a:xfrm>
          <a:prstGeom prst="rect">
            <a:avLst/>
          </a:prstGeom>
          <a:noFill/>
          <a:ln>
            <a:noFill/>
          </a:ln>
        </p:spPr>
      </p:pic>
      <p:sp>
        <p:nvSpPr>
          <p:cNvPr id="340" name="Google Shape;340;p25"/>
          <p:cNvSpPr txBox="1"/>
          <p:nvPr/>
        </p:nvSpPr>
        <p:spPr>
          <a:xfrm>
            <a:off x="327538" y="3817388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0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41" name="Google Shape;341;p25" title="HGD32_TFP-F_03_06_2024_Vika_AG_Std_1_1_shorter_copy.png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53500" y="4367200"/>
            <a:ext cx="1619411" cy="554600"/>
          </a:xfrm>
          <a:prstGeom prst="rect">
            <a:avLst/>
          </a:prstGeom>
          <a:noFill/>
          <a:ln>
            <a:noFill/>
          </a:ln>
        </p:spPr>
      </p:pic>
      <p:sp>
        <p:nvSpPr>
          <p:cNvPr id="342" name="Google Shape;342;p25"/>
          <p:cNvSpPr txBox="1"/>
          <p:nvPr/>
        </p:nvSpPr>
        <p:spPr>
          <a:xfrm>
            <a:off x="315338" y="49218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0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43" name="Google Shape;343;p25"/>
          <p:cNvSpPr txBox="1"/>
          <p:nvPr/>
        </p:nvSpPr>
        <p:spPr>
          <a:xfrm>
            <a:off x="140200" y="4205500"/>
            <a:ext cx="1791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773A&gt;C (p.Gln258Pro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47" name="Shape 3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" name="Google Shape;348;p26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49" name="Google Shape;349;p26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50" name="Google Shape;350;p26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51" name="Google Shape;351;p26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52" name="Google Shape;352;p26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53" name="Google Shape;353;p26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54" name="Google Shape;354;p26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1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355" name="Google Shape;355;p26" title="HGD11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556766"/>
          </a:xfrm>
          <a:prstGeom prst="rect">
            <a:avLst/>
          </a:prstGeom>
          <a:noFill/>
          <a:ln>
            <a:noFill/>
          </a:ln>
        </p:spPr>
      </p:pic>
      <p:sp>
        <p:nvSpPr>
          <p:cNvPr id="356" name="Google Shape;356;p26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1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357" name="Google Shape;357;p26"/>
          <p:cNvSpPr/>
          <p:nvPr/>
        </p:nvSpPr>
        <p:spPr>
          <a:xfrm rot="-5400000">
            <a:off x="4514625" y="-2245425"/>
            <a:ext cx="109500" cy="71244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58" name="Google Shape;358;p26"/>
          <p:cNvSpPr txBox="1"/>
          <p:nvPr/>
        </p:nvSpPr>
        <p:spPr>
          <a:xfrm>
            <a:off x="3924150" y="137152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1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59" name="Google Shape;359;p26" title="HGD33_1_TFP-F_25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899375"/>
            <a:ext cx="8839204" cy="487710"/>
          </a:xfrm>
          <a:prstGeom prst="rect">
            <a:avLst/>
          </a:prstGeom>
          <a:noFill/>
          <a:ln>
            <a:noFill/>
          </a:ln>
        </p:spPr>
      </p:pic>
      <p:sp>
        <p:nvSpPr>
          <p:cNvPr id="360" name="Google Shape;360;p26"/>
          <p:cNvSpPr/>
          <p:nvPr/>
        </p:nvSpPr>
        <p:spPr>
          <a:xfrm rot="-5400000">
            <a:off x="4967350" y="-803125"/>
            <a:ext cx="109500" cy="63900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61" name="Google Shape;361;p26"/>
          <p:cNvSpPr txBox="1"/>
          <p:nvPr/>
        </p:nvSpPr>
        <p:spPr>
          <a:xfrm>
            <a:off x="4374250" y="244662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1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62" name="Google Shape;362;p26"/>
          <p:cNvSpPr/>
          <p:nvPr/>
        </p:nvSpPr>
        <p:spPr>
          <a:xfrm rot="-5400000">
            <a:off x="1325125" y="1944575"/>
            <a:ext cx="109500" cy="89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63" name="Google Shape;363;p26"/>
          <p:cNvSpPr txBox="1"/>
          <p:nvPr/>
        </p:nvSpPr>
        <p:spPr>
          <a:xfrm>
            <a:off x="511225" y="2446625"/>
            <a:ext cx="1737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14-nt retention in exon 11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64" name="Google Shape;364;p26" title="HGD33_2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986" y="2667875"/>
            <a:ext cx="1607120" cy="556750"/>
          </a:xfrm>
          <a:prstGeom prst="rect">
            <a:avLst/>
          </a:prstGeom>
          <a:noFill/>
          <a:ln>
            <a:noFill/>
          </a:ln>
        </p:spPr>
      </p:pic>
      <p:sp>
        <p:nvSpPr>
          <p:cNvPr id="365" name="Google Shape;365;p26"/>
          <p:cNvSpPr txBox="1"/>
          <p:nvPr/>
        </p:nvSpPr>
        <p:spPr>
          <a:xfrm>
            <a:off x="308688" y="322462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1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66" name="Google Shape;366;p26"/>
          <p:cNvSpPr txBox="1"/>
          <p:nvPr/>
        </p:nvSpPr>
        <p:spPr>
          <a:xfrm>
            <a:off x="152400" y="175717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775-16T&gt;A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70" name="Shape 3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Google Shape;371;p27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2" name="Google Shape;372;p27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3" name="Google Shape;373;p27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4" name="Google Shape;374;p27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75" name="Google Shape;375;p27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76" name="Google Shape;376;p27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377" name="Google Shape;377;p27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2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378" name="Google Shape;378;p27" title="HGD12_1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474762"/>
          </a:xfrm>
          <a:prstGeom prst="rect">
            <a:avLst/>
          </a:prstGeom>
          <a:noFill/>
          <a:ln>
            <a:noFill/>
          </a:ln>
        </p:spPr>
      </p:pic>
      <p:sp>
        <p:nvSpPr>
          <p:cNvPr id="379" name="Google Shape;379;p27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2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380" name="Google Shape;380;p27"/>
          <p:cNvSpPr/>
          <p:nvPr/>
        </p:nvSpPr>
        <p:spPr>
          <a:xfrm rot="-5400000">
            <a:off x="4519400" y="-2440500"/>
            <a:ext cx="109500" cy="7362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81" name="Google Shape;381;p27"/>
          <p:cNvSpPr txBox="1"/>
          <p:nvPr/>
        </p:nvSpPr>
        <p:spPr>
          <a:xfrm>
            <a:off x="3926300" y="12954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82" name="Google Shape;382;p27" title="HGD12_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61625" y="1475213"/>
            <a:ext cx="1589849" cy="554600"/>
          </a:xfrm>
          <a:prstGeom prst="rect">
            <a:avLst/>
          </a:prstGeom>
          <a:noFill/>
          <a:ln>
            <a:noFill/>
          </a:ln>
        </p:spPr>
      </p:pic>
      <p:sp>
        <p:nvSpPr>
          <p:cNvPr id="383" name="Google Shape;383;p27"/>
          <p:cNvSpPr txBox="1"/>
          <p:nvPr/>
        </p:nvSpPr>
        <p:spPr>
          <a:xfrm>
            <a:off x="308688" y="2029813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84" name="Google Shape;384;p27" title="HGD34_1_TFP-F_25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13" y="2415438"/>
            <a:ext cx="8839204" cy="461814"/>
          </a:xfrm>
          <a:prstGeom prst="rect">
            <a:avLst/>
          </a:prstGeom>
          <a:noFill/>
          <a:ln>
            <a:noFill/>
          </a:ln>
        </p:spPr>
      </p:pic>
      <p:sp>
        <p:nvSpPr>
          <p:cNvPr id="385" name="Google Shape;385;p27"/>
          <p:cNvSpPr/>
          <p:nvPr/>
        </p:nvSpPr>
        <p:spPr>
          <a:xfrm rot="-5400000">
            <a:off x="4538588" y="-818787"/>
            <a:ext cx="109500" cy="7362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86" name="Google Shape;386;p27"/>
          <p:cNvSpPr txBox="1"/>
          <p:nvPr/>
        </p:nvSpPr>
        <p:spPr>
          <a:xfrm>
            <a:off x="3945488" y="2917113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87" name="Google Shape;387;p27"/>
          <p:cNvSpPr txBox="1"/>
          <p:nvPr/>
        </p:nvSpPr>
        <p:spPr>
          <a:xfrm>
            <a:off x="152413" y="2263033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006+6T&gt;C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388" name="Google Shape;388;p27" title="HGD34_2_TFP-F_03_06_2024_Vika_AG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375" y="3084588"/>
            <a:ext cx="1608340" cy="554600"/>
          </a:xfrm>
          <a:prstGeom prst="rect">
            <a:avLst/>
          </a:prstGeom>
          <a:noFill/>
          <a:ln>
            <a:noFill/>
          </a:ln>
        </p:spPr>
      </p:pic>
      <p:sp>
        <p:nvSpPr>
          <p:cNvPr id="389" name="Google Shape;389;p27"/>
          <p:cNvSpPr txBox="1"/>
          <p:nvPr/>
        </p:nvSpPr>
        <p:spPr>
          <a:xfrm>
            <a:off x="308688" y="3648113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90" name="Google Shape;390;p27" title="HGD35_1_TFP-F_03_06_2024_Vika_AG_Std_1_1_shorter_copy.png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52400" y="4038400"/>
            <a:ext cx="8839204" cy="470446"/>
          </a:xfrm>
          <a:prstGeom prst="rect">
            <a:avLst/>
          </a:prstGeom>
          <a:noFill/>
          <a:ln>
            <a:noFill/>
          </a:ln>
        </p:spPr>
      </p:pic>
      <p:sp>
        <p:nvSpPr>
          <p:cNvPr id="391" name="Google Shape;391;p27"/>
          <p:cNvSpPr/>
          <p:nvPr/>
        </p:nvSpPr>
        <p:spPr>
          <a:xfrm rot="-5400000">
            <a:off x="4517250" y="821275"/>
            <a:ext cx="109500" cy="7362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92" name="Google Shape;392;p27"/>
          <p:cNvSpPr txBox="1"/>
          <p:nvPr/>
        </p:nvSpPr>
        <p:spPr>
          <a:xfrm>
            <a:off x="3926300" y="455717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393" name="Google Shape;393;p27" title="HGD35_2_TFP-F_03_06_2024_Vika_AG_Std_1_1_shorter_copy.png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61623" y="4587611"/>
            <a:ext cx="1589850" cy="555889"/>
          </a:xfrm>
          <a:prstGeom prst="rect">
            <a:avLst/>
          </a:prstGeom>
          <a:noFill/>
          <a:ln>
            <a:noFill/>
          </a:ln>
        </p:spPr>
      </p:pic>
      <p:sp>
        <p:nvSpPr>
          <p:cNvPr id="394" name="Google Shape;394;p27"/>
          <p:cNvSpPr txBox="1"/>
          <p:nvPr/>
        </p:nvSpPr>
        <p:spPr>
          <a:xfrm>
            <a:off x="1671813" y="494612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2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395" name="Google Shape;395;p27"/>
          <p:cNvSpPr txBox="1"/>
          <p:nvPr/>
        </p:nvSpPr>
        <p:spPr>
          <a:xfrm>
            <a:off x="161613" y="38813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899T&gt;G (p.Val300Gly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99" name="Shape 3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Google Shape;400;p28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01" name="Google Shape;401;p28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02" name="Google Shape;402;p28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03" name="Google Shape;403;p28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04" name="Google Shape;404;p28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05" name="Google Shape;405;p28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06" name="Google Shape;406;p28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407" name="Google Shape;407;p28" title="HGD13_1_TFP-F_17_06_2024_PL1_RED_NI_povtor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336649"/>
          </a:xfrm>
          <a:prstGeom prst="rect">
            <a:avLst/>
          </a:prstGeom>
          <a:noFill/>
          <a:ln>
            <a:noFill/>
          </a:ln>
        </p:spPr>
      </p:pic>
      <p:sp>
        <p:nvSpPr>
          <p:cNvPr id="408" name="Google Shape;408;p28"/>
          <p:cNvSpPr txBox="1"/>
          <p:nvPr/>
        </p:nvSpPr>
        <p:spPr>
          <a:xfrm>
            <a:off x="144525" y="63274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3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09" name="Google Shape;409;p28"/>
          <p:cNvSpPr/>
          <p:nvPr/>
        </p:nvSpPr>
        <p:spPr>
          <a:xfrm rot="-5400000">
            <a:off x="4568400" y="-2726450"/>
            <a:ext cx="109500" cy="77049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10" name="Google Shape;410;p28"/>
          <p:cNvSpPr txBox="1"/>
          <p:nvPr/>
        </p:nvSpPr>
        <p:spPr>
          <a:xfrm>
            <a:off x="3975300" y="11807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11" name="Google Shape;411;p28" title="HGD13_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494850"/>
            <a:ext cx="8839200" cy="881569"/>
          </a:xfrm>
          <a:prstGeom prst="rect">
            <a:avLst/>
          </a:prstGeom>
          <a:noFill/>
          <a:ln>
            <a:noFill/>
          </a:ln>
        </p:spPr>
      </p:pic>
      <p:sp>
        <p:nvSpPr>
          <p:cNvPr id="412" name="Google Shape;412;p28"/>
          <p:cNvSpPr/>
          <p:nvPr/>
        </p:nvSpPr>
        <p:spPr>
          <a:xfrm rot="-5400000">
            <a:off x="4480400" y="-722500"/>
            <a:ext cx="109500" cy="6077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13" name="Google Shape;413;p28"/>
          <p:cNvSpPr txBox="1"/>
          <p:nvPr/>
        </p:nvSpPr>
        <p:spPr>
          <a:xfrm>
            <a:off x="3597500" y="2376425"/>
            <a:ext cx="1875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125-nt truncation of exon 13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14" name="Google Shape;414;p28" title="HGD13_3_TFP-F_17_06_2024_PL1_RED_NI_povtor_NI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609675"/>
            <a:ext cx="2456652" cy="881575"/>
          </a:xfrm>
          <a:prstGeom prst="rect">
            <a:avLst/>
          </a:prstGeom>
          <a:noFill/>
          <a:ln>
            <a:noFill/>
          </a:ln>
        </p:spPr>
      </p:pic>
      <p:sp>
        <p:nvSpPr>
          <p:cNvPr id="415" name="Google Shape;415;p28"/>
          <p:cNvSpPr txBox="1"/>
          <p:nvPr/>
        </p:nvSpPr>
        <p:spPr>
          <a:xfrm>
            <a:off x="681713" y="34912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16" name="Google Shape;416;p28" title="HGD_52-TFP-F_30_05_2025_pl2_red_Vika_AG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44525" y="4038600"/>
            <a:ext cx="8839204" cy="612874"/>
          </a:xfrm>
          <a:prstGeom prst="rect">
            <a:avLst/>
          </a:prstGeom>
          <a:noFill/>
          <a:ln>
            <a:noFill/>
          </a:ln>
        </p:spPr>
      </p:pic>
      <p:sp>
        <p:nvSpPr>
          <p:cNvPr id="417" name="Google Shape;417;p28"/>
          <p:cNvSpPr/>
          <p:nvPr/>
        </p:nvSpPr>
        <p:spPr>
          <a:xfrm rot="-5400000">
            <a:off x="4464650" y="1194650"/>
            <a:ext cx="109500" cy="68730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18" name="Google Shape;418;p28"/>
          <p:cNvSpPr txBox="1"/>
          <p:nvPr/>
        </p:nvSpPr>
        <p:spPr>
          <a:xfrm>
            <a:off x="3589625" y="4685900"/>
            <a:ext cx="1875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94-nt PE inclusion in exon 13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419" name="Google Shape;419;p28"/>
          <p:cNvSpPr/>
          <p:nvPr/>
        </p:nvSpPr>
        <p:spPr>
          <a:xfrm rot="-5400000">
            <a:off x="8399150" y="4133150"/>
            <a:ext cx="109500" cy="9960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20" name="Google Shape;420;p28"/>
          <p:cNvSpPr txBox="1"/>
          <p:nvPr/>
        </p:nvSpPr>
        <p:spPr>
          <a:xfrm>
            <a:off x="7806050" y="46859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421" name="Google Shape;421;p28"/>
          <p:cNvSpPr txBox="1"/>
          <p:nvPr/>
        </p:nvSpPr>
        <p:spPr>
          <a:xfrm>
            <a:off x="144525" y="38861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007-167A&gt;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25" name="Shape 4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Google Shape;426;p29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27" name="Google Shape;427;p29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28" name="Google Shape;428;p29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29" name="Google Shape;429;p29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30" name="Google Shape;430;p29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31" name="Google Shape;431;p29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32" name="Google Shape;432;p29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433" name="Google Shape;433;p29" title="HGD39_1-TFP-F_10_06_2024_PL1_RED_VIKA_povtor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345281"/>
          </a:xfrm>
          <a:prstGeom prst="rect">
            <a:avLst/>
          </a:prstGeom>
          <a:noFill/>
          <a:ln>
            <a:noFill/>
          </a:ln>
        </p:spPr>
      </p:pic>
      <p:sp>
        <p:nvSpPr>
          <p:cNvPr id="434" name="Google Shape;434;p29"/>
          <p:cNvSpPr txBox="1"/>
          <p:nvPr/>
        </p:nvSpPr>
        <p:spPr>
          <a:xfrm>
            <a:off x="152400" y="6327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007G&gt;A (p.Arg336Lys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35" name="Google Shape;435;p29"/>
          <p:cNvSpPr/>
          <p:nvPr/>
        </p:nvSpPr>
        <p:spPr>
          <a:xfrm rot="-5400000">
            <a:off x="4534575" y="-2760200"/>
            <a:ext cx="109500" cy="77724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36" name="Google Shape;436;p29"/>
          <p:cNvSpPr txBox="1"/>
          <p:nvPr/>
        </p:nvSpPr>
        <p:spPr>
          <a:xfrm>
            <a:off x="3941475" y="11807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37" name="Google Shape;437;p29" title="HGD36_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424650"/>
            <a:ext cx="1804121" cy="630813"/>
          </a:xfrm>
          <a:prstGeom prst="rect">
            <a:avLst/>
          </a:prstGeom>
          <a:noFill/>
          <a:ln>
            <a:noFill/>
          </a:ln>
        </p:spPr>
      </p:pic>
      <p:sp>
        <p:nvSpPr>
          <p:cNvPr id="438" name="Google Shape;438;p29"/>
          <p:cNvSpPr txBox="1"/>
          <p:nvPr/>
        </p:nvSpPr>
        <p:spPr>
          <a:xfrm>
            <a:off x="406600" y="205547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39" name="Google Shape;439;p29" title="HGD37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3384275"/>
            <a:ext cx="1804125" cy="633768"/>
          </a:xfrm>
          <a:prstGeom prst="rect">
            <a:avLst/>
          </a:prstGeom>
          <a:noFill/>
          <a:ln>
            <a:noFill/>
          </a:ln>
        </p:spPr>
      </p:pic>
      <p:pic>
        <p:nvPicPr>
          <p:cNvPr id="440" name="Google Shape;440;p29" title="HGD13_1_TFP-F_17_06_2024_PL1_RED_NI_povtor_NI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2711816"/>
            <a:ext cx="8839204" cy="336649"/>
          </a:xfrm>
          <a:prstGeom prst="rect">
            <a:avLst/>
          </a:prstGeom>
          <a:noFill/>
          <a:ln>
            <a:noFill/>
          </a:ln>
        </p:spPr>
      </p:pic>
      <p:sp>
        <p:nvSpPr>
          <p:cNvPr id="441" name="Google Shape;441;p29"/>
          <p:cNvSpPr txBox="1"/>
          <p:nvPr/>
        </p:nvSpPr>
        <p:spPr>
          <a:xfrm>
            <a:off x="152400" y="25594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007G&gt;C (p.Arg336Thr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42" name="Google Shape;442;p29"/>
          <p:cNvSpPr/>
          <p:nvPr/>
        </p:nvSpPr>
        <p:spPr>
          <a:xfrm rot="-5400000">
            <a:off x="4568400" y="-799750"/>
            <a:ext cx="109500" cy="77049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43" name="Google Shape;443;p29"/>
          <p:cNvSpPr txBox="1"/>
          <p:nvPr/>
        </p:nvSpPr>
        <p:spPr>
          <a:xfrm>
            <a:off x="3975300" y="31074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444" name="Google Shape;444;p29"/>
          <p:cNvSpPr txBox="1"/>
          <p:nvPr/>
        </p:nvSpPr>
        <p:spPr>
          <a:xfrm>
            <a:off x="406600" y="40180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48" name="Shape 4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Google Shape;449;p30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50" name="Google Shape;450;p30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51" name="Google Shape;451;p30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52" name="Google Shape;452;p30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53" name="Google Shape;453;p30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54" name="Google Shape;454;p30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55" name="Google Shape;455;p30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456" name="Google Shape;456;p30" title="HGD38_1_TFP-F_25_06_2024_Vika_AG_Std_1_1_shorter_copy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336649"/>
          </a:xfrm>
          <a:prstGeom prst="rect">
            <a:avLst/>
          </a:prstGeom>
          <a:noFill/>
          <a:ln>
            <a:noFill/>
          </a:ln>
        </p:spPr>
      </p:pic>
      <p:sp>
        <p:nvSpPr>
          <p:cNvPr id="457" name="Google Shape;457;p30"/>
          <p:cNvSpPr txBox="1"/>
          <p:nvPr/>
        </p:nvSpPr>
        <p:spPr>
          <a:xfrm>
            <a:off x="152400" y="6327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060C&gt;T (p.Gln354Ter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58" name="Google Shape;458;p30"/>
          <p:cNvSpPr/>
          <p:nvPr/>
        </p:nvSpPr>
        <p:spPr>
          <a:xfrm rot="-5400000">
            <a:off x="4534575" y="-2760200"/>
            <a:ext cx="109500" cy="77724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59" name="Google Shape;459;p30"/>
          <p:cNvSpPr txBox="1"/>
          <p:nvPr/>
        </p:nvSpPr>
        <p:spPr>
          <a:xfrm>
            <a:off x="3941475" y="11807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60" name="Google Shape;460;p30" title="HGD38_3_TFP-F_17_06_2024_PL1_RED_NI_povtor_NI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404875"/>
            <a:ext cx="1848475" cy="658600"/>
          </a:xfrm>
          <a:prstGeom prst="rect">
            <a:avLst/>
          </a:prstGeom>
          <a:noFill/>
          <a:ln>
            <a:noFill/>
          </a:ln>
        </p:spPr>
      </p:pic>
      <p:sp>
        <p:nvSpPr>
          <p:cNvPr id="461" name="Google Shape;461;p30"/>
          <p:cNvSpPr txBox="1"/>
          <p:nvPr/>
        </p:nvSpPr>
        <p:spPr>
          <a:xfrm>
            <a:off x="428775" y="206347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65" name="Shape 4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Google Shape;466;p31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67" name="Google Shape;467;p31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68" name="Google Shape;468;p31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69" name="Google Shape;469;p31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70" name="Google Shape;470;p31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71" name="Google Shape;471;p31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72" name="Google Shape;472;p31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473" name="Google Shape;473;p31" title="HGD39_1-TFP-F_10_06_2024_PL1_RED_VIKA_povtor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25"/>
            <a:ext cx="8839204" cy="345281"/>
          </a:xfrm>
          <a:prstGeom prst="rect">
            <a:avLst/>
          </a:prstGeom>
          <a:noFill/>
          <a:ln>
            <a:noFill/>
          </a:ln>
        </p:spPr>
      </p:pic>
      <p:sp>
        <p:nvSpPr>
          <p:cNvPr id="474" name="Google Shape;474;p31"/>
          <p:cNvSpPr txBox="1"/>
          <p:nvPr/>
        </p:nvSpPr>
        <p:spPr>
          <a:xfrm>
            <a:off x="152400" y="6327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188+8T&gt;A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75" name="Google Shape;475;p31"/>
          <p:cNvSpPr/>
          <p:nvPr/>
        </p:nvSpPr>
        <p:spPr>
          <a:xfrm rot="-5400000">
            <a:off x="4500825" y="-2735700"/>
            <a:ext cx="109500" cy="77049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76" name="Google Shape;476;p31"/>
          <p:cNvSpPr txBox="1"/>
          <p:nvPr/>
        </p:nvSpPr>
        <p:spPr>
          <a:xfrm>
            <a:off x="3907725" y="11715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77" name="Google Shape;477;p31" title="HGD39_3_TFP-F_17_06_2024_PL1_RED_NI_povtor_NI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651200"/>
            <a:ext cx="2474300" cy="883679"/>
          </a:xfrm>
          <a:prstGeom prst="rect">
            <a:avLst/>
          </a:prstGeom>
          <a:noFill/>
          <a:ln>
            <a:noFill/>
          </a:ln>
        </p:spPr>
      </p:pic>
      <p:sp>
        <p:nvSpPr>
          <p:cNvPr id="478" name="Google Shape;478;p31"/>
          <p:cNvSpPr txBox="1"/>
          <p:nvPr/>
        </p:nvSpPr>
        <p:spPr>
          <a:xfrm>
            <a:off x="775438" y="353487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479" name="Google Shape;479;p31" title="HGD39_2_TFP-F_17_06_2024_PL1_RED_NI_povtor_NI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1485600"/>
            <a:ext cx="8839200" cy="885100"/>
          </a:xfrm>
          <a:prstGeom prst="rect">
            <a:avLst/>
          </a:prstGeom>
          <a:noFill/>
          <a:ln>
            <a:noFill/>
          </a:ln>
        </p:spPr>
      </p:pic>
      <p:sp>
        <p:nvSpPr>
          <p:cNvPr id="480" name="Google Shape;480;p31"/>
          <p:cNvSpPr/>
          <p:nvPr/>
        </p:nvSpPr>
        <p:spPr>
          <a:xfrm rot="-5400000">
            <a:off x="4515325" y="-751800"/>
            <a:ext cx="109500" cy="60993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81" name="Google Shape;481;p31"/>
          <p:cNvSpPr txBox="1"/>
          <p:nvPr/>
        </p:nvSpPr>
        <p:spPr>
          <a:xfrm>
            <a:off x="3597500" y="2376425"/>
            <a:ext cx="1875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125-nt truncation of exon 13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6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14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78" name="Google Shape;78;p14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79" name="Google Shape;79;p14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0" name="Google Shape;80;p14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81" name="Google Shape;81;p14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82" name="Google Shape;82;p14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83" name="Google Shape;83;p14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84" name="Google Shape;84;p14" title="HGD3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94425"/>
            <a:ext cx="8839204" cy="630139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4"/>
          <p:cNvSpPr/>
          <p:nvPr/>
        </p:nvSpPr>
        <p:spPr>
          <a:xfrm rot="-5400000">
            <a:off x="4495300" y="-2009125"/>
            <a:ext cx="109500" cy="6820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6" name="Google Shape;86;p14"/>
          <p:cNvSpPr txBox="1"/>
          <p:nvPr/>
        </p:nvSpPr>
        <p:spPr>
          <a:xfrm>
            <a:off x="3940300" y="14583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3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87" name="Google Shape;87;p14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3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88" name="Google Shape;88;p14" title="HGD15_TFP-F_30_05_2024_PL2_GREEN_NI_NI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774750"/>
            <a:ext cx="8839204" cy="630139"/>
          </a:xfrm>
          <a:prstGeom prst="rect">
            <a:avLst/>
          </a:prstGeom>
          <a:noFill/>
          <a:ln>
            <a:noFill/>
          </a:ln>
        </p:spPr>
      </p:pic>
      <p:sp>
        <p:nvSpPr>
          <p:cNvPr id="89" name="Google Shape;89;p14"/>
          <p:cNvSpPr/>
          <p:nvPr/>
        </p:nvSpPr>
        <p:spPr>
          <a:xfrm rot="-5400000">
            <a:off x="4514450" y="-1019300"/>
            <a:ext cx="109500" cy="6848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0" name="Google Shape;90;p14"/>
          <p:cNvSpPr txBox="1"/>
          <p:nvPr/>
        </p:nvSpPr>
        <p:spPr>
          <a:xfrm>
            <a:off x="152400" y="158627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58G&gt;A (p.Arg53Gln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91" name="Google Shape;91;p14" title="HGD16_TFP-F_30_05_2024_PL2_GREEN_NI_NI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773900"/>
            <a:ext cx="8839202" cy="656376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p14"/>
          <p:cNvSpPr/>
          <p:nvPr/>
        </p:nvSpPr>
        <p:spPr>
          <a:xfrm rot="-5400000">
            <a:off x="4536000" y="1425"/>
            <a:ext cx="109500" cy="68154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3" name="Google Shape;93;p14"/>
          <p:cNvSpPr txBox="1"/>
          <p:nvPr/>
        </p:nvSpPr>
        <p:spPr>
          <a:xfrm>
            <a:off x="3786600" y="346387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4-nt truncation of exon 3</a:t>
            </a:r>
            <a:endParaRPr sz="1000">
              <a:solidFill>
                <a:schemeClr val="dk2"/>
              </a:solidFill>
            </a:endParaRPr>
          </a:p>
        </p:txBody>
      </p:sp>
      <p:cxnSp>
        <p:nvCxnSpPr>
          <p:cNvPr id="94" name="Google Shape;94;p14"/>
          <p:cNvCxnSpPr/>
          <p:nvPr/>
        </p:nvCxnSpPr>
        <p:spPr>
          <a:xfrm>
            <a:off x="7998450" y="3287850"/>
            <a:ext cx="0" cy="228600"/>
          </a:xfrm>
          <a:prstGeom prst="straightConnector1">
            <a:avLst/>
          </a:prstGeom>
          <a:noFill/>
          <a:ln cap="flat" cmpd="sng" w="19050">
            <a:solidFill>
              <a:srgbClr val="FF0000"/>
            </a:solidFill>
            <a:prstDash val="solid"/>
            <a:round/>
            <a:headEnd len="med" w="med" type="stealth"/>
            <a:tailEnd len="med" w="med" type="none"/>
          </a:ln>
        </p:spPr>
      </p:cxnSp>
      <p:sp>
        <p:nvSpPr>
          <p:cNvPr id="95" name="Google Shape;95;p14"/>
          <p:cNvSpPr txBox="1"/>
          <p:nvPr/>
        </p:nvSpPr>
        <p:spPr>
          <a:xfrm>
            <a:off x="3959450" y="2461113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3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96" name="Google Shape;96;p14"/>
          <p:cNvSpPr txBox="1"/>
          <p:nvPr/>
        </p:nvSpPr>
        <p:spPr>
          <a:xfrm>
            <a:off x="152400" y="26121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74A&gt;T (p.Arg58Ser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85" name="Shape 4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6" name="Google Shape;486;p32" title="HGD40_2-TFP-F_10_06_2024_PL1_RED_VIKA_povtor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478863"/>
            <a:ext cx="8839200" cy="892248"/>
          </a:xfrm>
          <a:prstGeom prst="rect">
            <a:avLst/>
          </a:prstGeom>
          <a:noFill/>
          <a:ln>
            <a:noFill/>
          </a:ln>
        </p:spPr>
      </p:pic>
      <p:sp>
        <p:nvSpPr>
          <p:cNvPr id="487" name="Google Shape;487;p32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88" name="Google Shape;488;p32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89" name="Google Shape;489;p32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90" name="Google Shape;490;p32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91" name="Google Shape;491;p32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92" name="Google Shape;492;p32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493" name="Google Shape;493;p32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3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494" name="Google Shape;494;p32" title="HGD40_1-TFP-F_10_06_2024_PL1_RED_VIKA_povtor_AG_Std_1_1_shorter_copy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785116"/>
            <a:ext cx="8839204" cy="345281"/>
          </a:xfrm>
          <a:prstGeom prst="rect">
            <a:avLst/>
          </a:prstGeom>
          <a:noFill/>
          <a:ln>
            <a:noFill/>
          </a:ln>
        </p:spPr>
      </p:pic>
      <p:sp>
        <p:nvSpPr>
          <p:cNvPr id="495" name="Google Shape;495;p32"/>
          <p:cNvSpPr txBox="1"/>
          <p:nvPr/>
        </p:nvSpPr>
        <p:spPr>
          <a:xfrm>
            <a:off x="152400" y="6327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188+8T&gt;C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496" name="Google Shape;496;p32"/>
          <p:cNvSpPr/>
          <p:nvPr/>
        </p:nvSpPr>
        <p:spPr>
          <a:xfrm rot="-5400000">
            <a:off x="4500825" y="-2735700"/>
            <a:ext cx="109500" cy="77049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97" name="Google Shape;497;p32"/>
          <p:cNvSpPr txBox="1"/>
          <p:nvPr/>
        </p:nvSpPr>
        <p:spPr>
          <a:xfrm>
            <a:off x="3907725" y="11715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498" name="Google Shape;498;p32"/>
          <p:cNvSpPr/>
          <p:nvPr/>
        </p:nvSpPr>
        <p:spPr>
          <a:xfrm rot="-5400000">
            <a:off x="4480400" y="-722500"/>
            <a:ext cx="109500" cy="6077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499" name="Google Shape;499;p32"/>
          <p:cNvSpPr txBox="1"/>
          <p:nvPr/>
        </p:nvSpPr>
        <p:spPr>
          <a:xfrm>
            <a:off x="3597500" y="2376425"/>
            <a:ext cx="1875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125-nt truncation of exon 13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500" name="Google Shape;500;p32" title="HGD13_3_TFP-F_17_06_2024_PL1_RED_NI_povtor_NI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643600"/>
            <a:ext cx="2456652" cy="881575"/>
          </a:xfrm>
          <a:prstGeom prst="rect">
            <a:avLst/>
          </a:prstGeom>
          <a:noFill/>
          <a:ln>
            <a:noFill/>
          </a:ln>
        </p:spPr>
      </p:pic>
      <p:sp>
        <p:nvSpPr>
          <p:cNvPr id="501" name="Google Shape;501;p32"/>
          <p:cNvSpPr txBox="1"/>
          <p:nvPr/>
        </p:nvSpPr>
        <p:spPr>
          <a:xfrm>
            <a:off x="681713" y="3525175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3 skipping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05" name="Shape 5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Google Shape;506;p33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07" name="Google Shape;507;p33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08" name="Google Shape;508;p33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09" name="Google Shape;509;p33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510" name="Google Shape;510;p33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511" name="Google Shape;511;p33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512" name="Google Shape;512;p33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14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513" name="Google Shape;513;p33" title="HGD14_TFP-F_17_06_2024_PL1_RED_NI_povtor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267593"/>
          </a:xfrm>
          <a:prstGeom prst="rect">
            <a:avLst/>
          </a:prstGeom>
          <a:noFill/>
          <a:ln>
            <a:noFill/>
          </a:ln>
        </p:spPr>
      </p:pic>
      <p:sp>
        <p:nvSpPr>
          <p:cNvPr id="514" name="Google Shape;514;p33"/>
          <p:cNvSpPr txBox="1"/>
          <p:nvPr/>
        </p:nvSpPr>
        <p:spPr>
          <a:xfrm>
            <a:off x="152400" y="632725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14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515" name="Google Shape;515;p33"/>
          <p:cNvSpPr/>
          <p:nvPr/>
        </p:nvSpPr>
        <p:spPr>
          <a:xfrm rot="-5400000">
            <a:off x="3128425" y="-1516150"/>
            <a:ext cx="109500" cy="51741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16" name="Google Shape;516;p33"/>
          <p:cNvSpPr txBox="1"/>
          <p:nvPr/>
        </p:nvSpPr>
        <p:spPr>
          <a:xfrm>
            <a:off x="2535325" y="112565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4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517" name="Google Shape;517;p33"/>
          <p:cNvSpPr/>
          <p:nvPr/>
        </p:nvSpPr>
        <p:spPr>
          <a:xfrm rot="-5400000">
            <a:off x="7003225" y="-216850"/>
            <a:ext cx="109500" cy="25755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18" name="Google Shape;518;p33"/>
          <p:cNvSpPr txBox="1"/>
          <p:nvPr/>
        </p:nvSpPr>
        <p:spPr>
          <a:xfrm>
            <a:off x="6232975" y="1125650"/>
            <a:ext cx="16500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HGD 3’-UTR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519" name="Google Shape;519;p33" title="HGD41_TFP-F_17_06_2024_PL1_RED_NI_povtor_NI_Std_1_1_shorter_copy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439750"/>
            <a:ext cx="8839204" cy="267593"/>
          </a:xfrm>
          <a:prstGeom prst="rect">
            <a:avLst/>
          </a:prstGeom>
          <a:noFill/>
          <a:ln>
            <a:noFill/>
          </a:ln>
        </p:spPr>
      </p:pic>
      <p:sp>
        <p:nvSpPr>
          <p:cNvPr id="520" name="Google Shape;520;p33"/>
          <p:cNvSpPr txBox="1"/>
          <p:nvPr/>
        </p:nvSpPr>
        <p:spPr>
          <a:xfrm>
            <a:off x="152400" y="1287350"/>
            <a:ext cx="20412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189-8T&gt;A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521" name="Google Shape;521;p33"/>
          <p:cNvSpPr/>
          <p:nvPr/>
        </p:nvSpPr>
        <p:spPr>
          <a:xfrm rot="-5400000">
            <a:off x="3128425" y="-848600"/>
            <a:ext cx="109500" cy="51741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22" name="Google Shape;522;p33"/>
          <p:cNvSpPr txBox="1"/>
          <p:nvPr/>
        </p:nvSpPr>
        <p:spPr>
          <a:xfrm>
            <a:off x="2535325" y="1793200"/>
            <a:ext cx="12957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14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523" name="Google Shape;523;p33"/>
          <p:cNvSpPr/>
          <p:nvPr/>
        </p:nvSpPr>
        <p:spPr>
          <a:xfrm rot="-5400000">
            <a:off x="7003225" y="450700"/>
            <a:ext cx="109500" cy="25755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24" name="Google Shape;524;p33"/>
          <p:cNvSpPr txBox="1"/>
          <p:nvPr/>
        </p:nvSpPr>
        <p:spPr>
          <a:xfrm>
            <a:off x="6232975" y="1793200"/>
            <a:ext cx="16500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HGD 3’-UTR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525" name="Google Shape;525;p33"/>
          <p:cNvSpPr/>
          <p:nvPr/>
        </p:nvSpPr>
        <p:spPr>
          <a:xfrm>
            <a:off x="58911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C6F6F1"/>
          </a:solidFill>
          <a:ln cap="flat" cmpd="sng" w="9525">
            <a:solidFill>
              <a:srgbClr val="C6F6F1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26" name="Google Shape;526;p33"/>
          <p:cNvSpPr txBox="1"/>
          <p:nvPr/>
        </p:nvSpPr>
        <p:spPr>
          <a:xfrm>
            <a:off x="60528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HGD 3’-UTR</a:t>
            </a:r>
            <a:endParaRPr b="1" sz="12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0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15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2" name="Google Shape;102;p15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3" name="Google Shape;103;p15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4" name="Google Shape;104;p15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05" name="Google Shape;105;p15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06" name="Google Shape;106;p15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07" name="Google Shape;107;p15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4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08" name="Google Shape;108;p15" title="HGD4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548134"/>
          </a:xfrm>
          <a:prstGeom prst="rect">
            <a:avLst/>
          </a:prstGeom>
          <a:noFill/>
          <a:ln>
            <a:noFill/>
          </a:ln>
        </p:spPr>
      </p:pic>
      <p:sp>
        <p:nvSpPr>
          <p:cNvPr id="109" name="Google Shape;109;p15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4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10" name="Google Shape;110;p15"/>
          <p:cNvSpPr/>
          <p:nvPr/>
        </p:nvSpPr>
        <p:spPr>
          <a:xfrm rot="-5400000">
            <a:off x="4531125" y="-2240000"/>
            <a:ext cx="109500" cy="7120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1" name="Google Shape;111;p15"/>
          <p:cNvSpPr txBox="1"/>
          <p:nvPr/>
        </p:nvSpPr>
        <p:spPr>
          <a:xfrm>
            <a:off x="3976125" y="13748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4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112" name="Google Shape;112;p15" title="HGD17_TFP-F_30_05_2024_PL2_GREEN_NI_NI_Std_1_1_shorter_copy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688950"/>
            <a:ext cx="8839204" cy="548134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15"/>
          <p:cNvSpPr/>
          <p:nvPr/>
        </p:nvSpPr>
        <p:spPr>
          <a:xfrm rot="-5400000">
            <a:off x="4531125" y="-1321550"/>
            <a:ext cx="109500" cy="7120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4" name="Google Shape;114;p15"/>
          <p:cNvSpPr txBox="1"/>
          <p:nvPr/>
        </p:nvSpPr>
        <p:spPr>
          <a:xfrm>
            <a:off x="3976125" y="22933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4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115" name="Google Shape;115;p15"/>
          <p:cNvSpPr txBox="1"/>
          <p:nvPr/>
        </p:nvSpPr>
        <p:spPr>
          <a:xfrm>
            <a:off x="152400" y="152724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177-35T&gt;G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9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16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1" name="Google Shape;121;p16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2" name="Google Shape;122;p16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23" name="Google Shape;123;p16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24" name="Google Shape;124;p16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25" name="Google Shape;125;p16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26" name="Google Shape;126;p16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5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27" name="Google Shape;127;p16" title="HGD5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197" cy="857619"/>
          </a:xfrm>
          <a:prstGeom prst="rect">
            <a:avLst/>
          </a:prstGeom>
          <a:noFill/>
          <a:ln>
            <a:noFill/>
          </a:ln>
        </p:spPr>
      </p:pic>
      <p:sp>
        <p:nvSpPr>
          <p:cNvPr id="128" name="Google Shape;128;p16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5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29" name="Google Shape;129;p16"/>
          <p:cNvSpPr/>
          <p:nvPr/>
        </p:nvSpPr>
        <p:spPr>
          <a:xfrm rot="-5400000">
            <a:off x="4507525" y="-1505625"/>
            <a:ext cx="109500" cy="6187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0" name="Google Shape;130;p16"/>
          <p:cNvSpPr txBox="1"/>
          <p:nvPr/>
        </p:nvSpPr>
        <p:spPr>
          <a:xfrm>
            <a:off x="3952525" y="16427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5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131" name="Google Shape;131;p16" title="HGD18_1_TFP-F_30_05_2024_PL2_GREEN_NI_NI_Std_1_1_shorter_copy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956825"/>
            <a:ext cx="8839204" cy="574030"/>
          </a:xfrm>
          <a:prstGeom prst="rect">
            <a:avLst/>
          </a:prstGeom>
          <a:noFill/>
          <a:ln>
            <a:noFill/>
          </a:ln>
        </p:spPr>
      </p:pic>
      <p:sp>
        <p:nvSpPr>
          <p:cNvPr id="132" name="Google Shape;132;p16"/>
          <p:cNvSpPr/>
          <p:nvPr/>
        </p:nvSpPr>
        <p:spPr>
          <a:xfrm rot="-5400000">
            <a:off x="2942175" y="522600"/>
            <a:ext cx="109500" cy="39888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3" name="Google Shape;133;p16"/>
          <p:cNvSpPr txBox="1"/>
          <p:nvPr/>
        </p:nvSpPr>
        <p:spPr>
          <a:xfrm>
            <a:off x="2387175" y="25717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5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134" name="Google Shape;134;p16"/>
          <p:cNvSpPr/>
          <p:nvPr/>
        </p:nvSpPr>
        <p:spPr>
          <a:xfrm rot="-5400000">
            <a:off x="6523425" y="930150"/>
            <a:ext cx="109500" cy="3173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5" name="Google Shape;135;p16"/>
          <p:cNvSpPr txBox="1"/>
          <p:nvPr/>
        </p:nvSpPr>
        <p:spPr>
          <a:xfrm>
            <a:off x="5561925" y="2571750"/>
            <a:ext cx="2032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49-nt retention of intron 5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136" name="Google Shape;136;p16"/>
          <p:cNvSpPr txBox="1"/>
          <p:nvPr/>
        </p:nvSpPr>
        <p:spPr>
          <a:xfrm>
            <a:off x="152400" y="17951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342+3A&gt;C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137" name="Google Shape;137;p16" title="HGD18_2_TFP-F_30_05_2024_PL2_GREEN_NI_NI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885850"/>
            <a:ext cx="8839201" cy="926541"/>
          </a:xfrm>
          <a:prstGeom prst="rect">
            <a:avLst/>
          </a:prstGeom>
          <a:noFill/>
          <a:ln>
            <a:noFill/>
          </a:ln>
        </p:spPr>
      </p:pic>
      <p:sp>
        <p:nvSpPr>
          <p:cNvPr id="138" name="Google Shape;138;p16"/>
          <p:cNvSpPr/>
          <p:nvPr/>
        </p:nvSpPr>
        <p:spPr>
          <a:xfrm rot="-5400000">
            <a:off x="4493150" y="778350"/>
            <a:ext cx="109500" cy="5958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9" name="Google Shape;139;p16"/>
          <p:cNvSpPr txBox="1"/>
          <p:nvPr/>
        </p:nvSpPr>
        <p:spPr>
          <a:xfrm>
            <a:off x="3531650" y="3812400"/>
            <a:ext cx="2032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6-nt truncation of exon 5</a:t>
            </a:r>
            <a:endParaRPr sz="1000">
              <a:solidFill>
                <a:schemeClr val="dk2"/>
              </a:solidFill>
            </a:endParaRPr>
          </a:p>
        </p:txBody>
      </p:sp>
      <p:cxnSp>
        <p:nvCxnSpPr>
          <p:cNvPr id="140" name="Google Shape;140;p16"/>
          <p:cNvCxnSpPr/>
          <p:nvPr/>
        </p:nvCxnSpPr>
        <p:spPr>
          <a:xfrm>
            <a:off x="7551175" y="3620925"/>
            <a:ext cx="0" cy="228600"/>
          </a:xfrm>
          <a:prstGeom prst="straightConnector1">
            <a:avLst/>
          </a:prstGeom>
          <a:noFill/>
          <a:ln cap="flat" cmpd="sng" w="19050">
            <a:solidFill>
              <a:srgbClr val="FF0000"/>
            </a:solidFill>
            <a:prstDash val="solid"/>
            <a:round/>
            <a:headEnd len="med" w="med" type="stealth"/>
            <a:tailEnd len="med" w="med" type="none"/>
          </a:ln>
        </p:spPr>
      </p:cxnSp>
      <p:pic>
        <p:nvPicPr>
          <p:cNvPr id="141" name="Google Shape;141;p16" title="HGD5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71650" y="4117191"/>
            <a:ext cx="8839197" cy="857619"/>
          </a:xfrm>
          <a:prstGeom prst="rect">
            <a:avLst/>
          </a:prstGeom>
          <a:noFill/>
          <a:ln>
            <a:noFill/>
          </a:ln>
        </p:spPr>
      </p:pic>
      <p:sp>
        <p:nvSpPr>
          <p:cNvPr id="142" name="Google Shape;142;p16"/>
          <p:cNvSpPr txBox="1"/>
          <p:nvPr/>
        </p:nvSpPr>
        <p:spPr>
          <a:xfrm>
            <a:off x="71650" y="39647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342+9G&gt;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43" name="Google Shape;143;p16"/>
          <p:cNvSpPr/>
          <p:nvPr/>
        </p:nvSpPr>
        <p:spPr>
          <a:xfrm rot="-5400000">
            <a:off x="4426775" y="1826450"/>
            <a:ext cx="109500" cy="61872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4" name="Google Shape;144;p16"/>
          <p:cNvSpPr txBox="1"/>
          <p:nvPr/>
        </p:nvSpPr>
        <p:spPr>
          <a:xfrm>
            <a:off x="3871775" y="49748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5 full length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8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p17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0" name="Google Shape;150;p17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1" name="Google Shape;151;p17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2" name="Google Shape;152;p17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53" name="Google Shape;153;p17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54" name="Google Shape;154;p17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55" name="Google Shape;155;p17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6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56" name="Google Shape;156;p17" title="HGD6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612874"/>
          </a:xfrm>
          <a:prstGeom prst="rect">
            <a:avLst/>
          </a:prstGeom>
          <a:noFill/>
          <a:ln>
            <a:noFill/>
          </a:ln>
        </p:spPr>
      </p:pic>
      <p:sp>
        <p:nvSpPr>
          <p:cNvPr id="157" name="Google Shape;157;p17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6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58" name="Google Shape;158;p17"/>
          <p:cNvSpPr/>
          <p:nvPr/>
        </p:nvSpPr>
        <p:spPr>
          <a:xfrm rot="-5400000">
            <a:off x="4519375" y="-2088425"/>
            <a:ext cx="109500" cy="692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59" name="Google Shape;159;p17"/>
          <p:cNvSpPr txBox="1"/>
          <p:nvPr/>
        </p:nvSpPr>
        <p:spPr>
          <a:xfrm>
            <a:off x="3964375" y="14286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160" name="Google Shape;160;p17" title="HGD20_TFP-F_03_06_2024_Vika_AG_Std_1_1_shorter_copy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742725"/>
            <a:ext cx="8839204" cy="608558"/>
          </a:xfrm>
          <a:prstGeom prst="rect">
            <a:avLst/>
          </a:prstGeom>
          <a:noFill/>
          <a:ln>
            <a:noFill/>
          </a:ln>
        </p:spPr>
      </p:pic>
      <p:sp>
        <p:nvSpPr>
          <p:cNvPr id="161" name="Google Shape;161;p17"/>
          <p:cNvSpPr/>
          <p:nvPr/>
        </p:nvSpPr>
        <p:spPr>
          <a:xfrm rot="-5400000">
            <a:off x="4519375" y="-1127150"/>
            <a:ext cx="109500" cy="692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2" name="Google Shape;162;p17"/>
          <p:cNvSpPr txBox="1"/>
          <p:nvPr/>
        </p:nvSpPr>
        <p:spPr>
          <a:xfrm>
            <a:off x="3964375" y="23899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163" name="Google Shape;163;p17"/>
          <p:cNvSpPr txBox="1"/>
          <p:nvPr/>
        </p:nvSpPr>
        <p:spPr>
          <a:xfrm>
            <a:off x="152400" y="15903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343-6T&gt;A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pic>
        <p:nvPicPr>
          <p:cNvPr id="164" name="Google Shape;164;p17" title="HGD21_1-TFP-F_10_06_2024_PL1_RED_VIKA_povtor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2704000"/>
            <a:ext cx="8839204" cy="621507"/>
          </a:xfrm>
          <a:prstGeom prst="rect">
            <a:avLst/>
          </a:prstGeom>
          <a:noFill/>
          <a:ln>
            <a:noFill/>
          </a:ln>
        </p:spPr>
      </p:pic>
      <p:sp>
        <p:nvSpPr>
          <p:cNvPr id="165" name="Google Shape;165;p17"/>
          <p:cNvSpPr txBox="1"/>
          <p:nvPr/>
        </p:nvSpPr>
        <p:spPr>
          <a:xfrm>
            <a:off x="152400" y="252304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343G&gt;C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66" name="Google Shape;166;p17"/>
          <p:cNvSpPr/>
          <p:nvPr/>
        </p:nvSpPr>
        <p:spPr>
          <a:xfrm rot="-5400000">
            <a:off x="4519375" y="-107975"/>
            <a:ext cx="109500" cy="692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67" name="Google Shape;167;p17"/>
          <p:cNvSpPr txBox="1"/>
          <p:nvPr/>
        </p:nvSpPr>
        <p:spPr>
          <a:xfrm>
            <a:off x="3964375" y="340907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168" name="Google Shape;168;p17" title="HGD21_2_TFP-F_03_06_2024_Vika_AG_Std_1_1_shorter_copy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6" y="3639600"/>
            <a:ext cx="1806489" cy="621500"/>
          </a:xfrm>
          <a:prstGeom prst="rect">
            <a:avLst/>
          </a:prstGeom>
          <a:noFill/>
          <a:ln>
            <a:noFill/>
          </a:ln>
        </p:spPr>
      </p:pic>
      <p:sp>
        <p:nvSpPr>
          <p:cNvPr id="169" name="Google Shape;169;p17"/>
          <p:cNvSpPr txBox="1"/>
          <p:nvPr/>
        </p:nvSpPr>
        <p:spPr>
          <a:xfrm>
            <a:off x="448013" y="42611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skipping</a:t>
            </a:r>
            <a:endParaRPr sz="10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73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18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5" name="Google Shape;175;p18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6" name="Google Shape;176;p18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77" name="Google Shape;177;p18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78" name="Google Shape;178;p18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79" name="Google Shape;179;p18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80" name="Google Shape;180;p18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6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181" name="Google Shape;181;p18" title="HGD6_TFP-F_30_05_2024_PL2_GREEN_NI_NI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4" cy="612874"/>
          </a:xfrm>
          <a:prstGeom prst="rect">
            <a:avLst/>
          </a:prstGeom>
          <a:noFill/>
          <a:ln>
            <a:noFill/>
          </a:ln>
        </p:spPr>
      </p:pic>
      <p:sp>
        <p:nvSpPr>
          <p:cNvPr id="182" name="Google Shape;182;p18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6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183" name="Google Shape;183;p18"/>
          <p:cNvSpPr/>
          <p:nvPr/>
        </p:nvSpPr>
        <p:spPr>
          <a:xfrm rot="-5400000">
            <a:off x="4519375" y="-2088425"/>
            <a:ext cx="109500" cy="692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4" name="Google Shape;184;p18"/>
          <p:cNvSpPr txBox="1"/>
          <p:nvPr/>
        </p:nvSpPr>
        <p:spPr>
          <a:xfrm>
            <a:off x="3964375" y="1428625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185" name="Google Shape;185;p18" title="HGD22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742725"/>
            <a:ext cx="8839204" cy="612874"/>
          </a:xfrm>
          <a:prstGeom prst="rect">
            <a:avLst/>
          </a:prstGeom>
          <a:noFill/>
          <a:ln>
            <a:noFill/>
          </a:ln>
        </p:spPr>
      </p:pic>
      <p:sp>
        <p:nvSpPr>
          <p:cNvPr id="186" name="Google Shape;186;p18"/>
          <p:cNvSpPr/>
          <p:nvPr/>
        </p:nvSpPr>
        <p:spPr>
          <a:xfrm rot="-5400000">
            <a:off x="4519375" y="-1127150"/>
            <a:ext cx="109500" cy="69246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7" name="Google Shape;187;p18"/>
          <p:cNvSpPr txBox="1"/>
          <p:nvPr/>
        </p:nvSpPr>
        <p:spPr>
          <a:xfrm>
            <a:off x="3964375" y="23899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6 full length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188" name="Google Shape;188;p18"/>
          <p:cNvSpPr txBox="1"/>
          <p:nvPr/>
        </p:nvSpPr>
        <p:spPr>
          <a:xfrm>
            <a:off x="152400" y="15810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433A&gt;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92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Google Shape;193;p19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4" name="Google Shape;194;p19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5" name="Google Shape;195;p19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96" name="Google Shape;196;p19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97" name="Google Shape;197;p19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98" name="Google Shape;198;p19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199" name="Google Shape;199;p19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7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200" name="Google Shape;200;p19" title="HGD7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0" cy="1216404"/>
          </a:xfrm>
          <a:prstGeom prst="rect">
            <a:avLst/>
          </a:prstGeom>
          <a:noFill/>
          <a:ln>
            <a:noFill/>
          </a:ln>
        </p:spPr>
      </p:pic>
      <p:sp>
        <p:nvSpPr>
          <p:cNvPr id="201" name="Google Shape;201;p19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7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02" name="Google Shape;202;p19"/>
          <p:cNvSpPr/>
          <p:nvPr/>
        </p:nvSpPr>
        <p:spPr>
          <a:xfrm rot="-5400000">
            <a:off x="4505175" y="-651400"/>
            <a:ext cx="109500" cy="5135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3" name="Google Shape;203;p19"/>
          <p:cNvSpPr txBox="1"/>
          <p:nvPr/>
        </p:nvSpPr>
        <p:spPr>
          <a:xfrm>
            <a:off x="3950175" y="19712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04" name="Google Shape;204;p19" title="HGD23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285300"/>
            <a:ext cx="8839199" cy="1219761"/>
          </a:xfrm>
          <a:prstGeom prst="rect">
            <a:avLst/>
          </a:prstGeom>
          <a:noFill/>
          <a:ln>
            <a:noFill/>
          </a:ln>
        </p:spPr>
      </p:pic>
      <p:sp>
        <p:nvSpPr>
          <p:cNvPr id="205" name="Google Shape;205;p19"/>
          <p:cNvSpPr txBox="1"/>
          <p:nvPr/>
        </p:nvSpPr>
        <p:spPr>
          <a:xfrm>
            <a:off x="152400" y="2123600"/>
            <a:ext cx="18396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455G&gt;C (p.Gly152Ala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06" name="Google Shape;206;p19"/>
          <p:cNvSpPr/>
          <p:nvPr/>
        </p:nvSpPr>
        <p:spPr>
          <a:xfrm rot="-5400000">
            <a:off x="4505175" y="857050"/>
            <a:ext cx="109500" cy="5135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07" name="Google Shape;207;p19"/>
          <p:cNvSpPr txBox="1"/>
          <p:nvPr/>
        </p:nvSpPr>
        <p:spPr>
          <a:xfrm>
            <a:off x="3950175" y="34796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08" name="Google Shape;208;p19" title="HGD24_TFP-F_03_06_2024_Vika_AG_Std_1_1_shorter_copy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388" y="3788825"/>
            <a:ext cx="3472315" cy="1197350"/>
          </a:xfrm>
          <a:prstGeom prst="rect">
            <a:avLst/>
          </a:prstGeom>
          <a:noFill/>
          <a:ln>
            <a:noFill/>
          </a:ln>
        </p:spPr>
      </p:pic>
      <p:sp>
        <p:nvSpPr>
          <p:cNvPr id="209" name="Google Shape;209;p19"/>
          <p:cNvSpPr txBox="1"/>
          <p:nvPr/>
        </p:nvSpPr>
        <p:spPr>
          <a:xfrm>
            <a:off x="1290863" y="49818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210" name="Google Shape;210;p19"/>
          <p:cNvSpPr txBox="1"/>
          <p:nvPr/>
        </p:nvSpPr>
        <p:spPr>
          <a:xfrm>
            <a:off x="152400" y="365744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469+5G&gt;A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14" name="Shape 2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Google Shape;215;p20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6" name="Google Shape;216;p20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7" name="Google Shape;217;p20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8" name="Google Shape;218;p20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19" name="Google Shape;219;p20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20" name="Google Shape;220;p20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21" name="Google Shape;221;p20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7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222" name="Google Shape;222;p20" title="HGD7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0" cy="1216404"/>
          </a:xfrm>
          <a:prstGeom prst="rect">
            <a:avLst/>
          </a:prstGeom>
          <a:noFill/>
          <a:ln>
            <a:noFill/>
          </a:ln>
        </p:spPr>
      </p:pic>
      <p:sp>
        <p:nvSpPr>
          <p:cNvPr id="223" name="Google Shape;223;p20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7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24" name="Google Shape;224;p20"/>
          <p:cNvSpPr/>
          <p:nvPr/>
        </p:nvSpPr>
        <p:spPr>
          <a:xfrm rot="-5400000">
            <a:off x="4505175" y="-651400"/>
            <a:ext cx="109500" cy="5135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5" name="Google Shape;225;p20"/>
          <p:cNvSpPr txBox="1"/>
          <p:nvPr/>
        </p:nvSpPr>
        <p:spPr>
          <a:xfrm>
            <a:off x="3950175" y="19712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26" name="Google Shape;226;p20" title="HGD25_1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285300"/>
            <a:ext cx="8839200" cy="1216404"/>
          </a:xfrm>
          <a:prstGeom prst="rect">
            <a:avLst/>
          </a:prstGeom>
          <a:noFill/>
          <a:ln>
            <a:noFill/>
          </a:ln>
        </p:spPr>
      </p:pic>
      <p:sp>
        <p:nvSpPr>
          <p:cNvPr id="227" name="Google Shape;227;p20"/>
          <p:cNvSpPr/>
          <p:nvPr/>
        </p:nvSpPr>
        <p:spPr>
          <a:xfrm rot="-5400000">
            <a:off x="4517250" y="857050"/>
            <a:ext cx="109500" cy="5135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28" name="Google Shape;228;p20"/>
          <p:cNvSpPr txBox="1"/>
          <p:nvPr/>
        </p:nvSpPr>
        <p:spPr>
          <a:xfrm>
            <a:off x="3962250" y="34796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29" name="Google Shape;229;p20" title="HGD25_2_TFP-F_03_06_2024_Vika_AG_Std_1_1_shorter_copy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3715775"/>
            <a:ext cx="3480297" cy="1197350"/>
          </a:xfrm>
          <a:prstGeom prst="rect">
            <a:avLst/>
          </a:prstGeom>
          <a:noFill/>
          <a:ln>
            <a:noFill/>
          </a:ln>
        </p:spPr>
      </p:pic>
      <p:sp>
        <p:nvSpPr>
          <p:cNvPr id="230" name="Google Shape;230;p20"/>
          <p:cNvSpPr txBox="1"/>
          <p:nvPr/>
        </p:nvSpPr>
        <p:spPr>
          <a:xfrm>
            <a:off x="1294863" y="49121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231" name="Google Shape;231;p20"/>
          <p:cNvSpPr txBox="1"/>
          <p:nvPr/>
        </p:nvSpPr>
        <p:spPr>
          <a:xfrm>
            <a:off x="152400" y="2123595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469+6T&gt;C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35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21"/>
          <p:cNvSpPr/>
          <p:nvPr/>
        </p:nvSpPr>
        <p:spPr>
          <a:xfrm>
            <a:off x="1524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FF3B3"/>
          </a:solidFill>
          <a:ln cap="flat" cmpd="sng" w="9525">
            <a:solidFill>
              <a:srgbClr val="FFF3B3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7" name="Google Shape;237;p21"/>
          <p:cNvSpPr/>
          <p:nvPr/>
        </p:nvSpPr>
        <p:spPr>
          <a:xfrm>
            <a:off x="20653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F5E3F5"/>
          </a:solidFill>
          <a:ln cap="flat" cmpd="sng" w="9525">
            <a:solidFill>
              <a:srgbClr val="F5E3F5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8" name="Google Shape;238;p21"/>
          <p:cNvSpPr/>
          <p:nvPr/>
        </p:nvSpPr>
        <p:spPr>
          <a:xfrm>
            <a:off x="3978200" y="99900"/>
            <a:ext cx="161700" cy="161700"/>
          </a:xfrm>
          <a:prstGeom prst="roundRect">
            <a:avLst>
              <a:gd fmla="val 16667" name="adj"/>
            </a:avLst>
          </a:prstGeom>
          <a:solidFill>
            <a:srgbClr val="E5F1DD"/>
          </a:solidFill>
          <a:ln cap="flat" cmpd="sng" w="9525">
            <a:solidFill>
              <a:srgbClr val="E5F1DD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39" name="Google Shape;239;p21"/>
          <p:cNvSpPr txBox="1"/>
          <p:nvPr/>
        </p:nvSpPr>
        <p:spPr>
          <a:xfrm>
            <a:off x="3141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T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40" name="Google Shape;240;p21"/>
          <p:cNvSpPr txBox="1"/>
          <p:nvPr/>
        </p:nvSpPr>
        <p:spPr>
          <a:xfrm>
            <a:off x="2227000" y="57000"/>
            <a:ext cx="10659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GFP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41" name="Google Shape;241;p21"/>
          <p:cNvSpPr txBox="1"/>
          <p:nvPr/>
        </p:nvSpPr>
        <p:spPr>
          <a:xfrm>
            <a:off x="4139900" y="57000"/>
            <a:ext cx="1417500" cy="2475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WT Exon</a:t>
            </a:r>
            <a:endParaRPr b="1" sz="1200">
              <a:solidFill>
                <a:schemeClr val="dk2"/>
              </a:solidFill>
            </a:endParaRPr>
          </a:p>
        </p:txBody>
      </p:sp>
      <p:sp>
        <p:nvSpPr>
          <p:cNvPr id="242" name="Google Shape;242;p21"/>
          <p:cNvSpPr txBox="1"/>
          <p:nvPr/>
        </p:nvSpPr>
        <p:spPr>
          <a:xfrm>
            <a:off x="0" y="261616"/>
            <a:ext cx="1608300" cy="371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200">
                <a:solidFill>
                  <a:schemeClr val="dk2"/>
                </a:solidFill>
              </a:rPr>
              <a:t>Exon 7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243" name="Google Shape;243;p21" title="HGD7_TFP-F_03_06_2024_Vika_AG_Std_1_1_shorter_copy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785116"/>
            <a:ext cx="8839200" cy="1216404"/>
          </a:xfrm>
          <a:prstGeom prst="rect">
            <a:avLst/>
          </a:prstGeom>
          <a:noFill/>
          <a:ln>
            <a:noFill/>
          </a:ln>
        </p:spPr>
      </p:pic>
      <p:sp>
        <p:nvSpPr>
          <p:cNvPr id="244" name="Google Shape;244;p21"/>
          <p:cNvSpPr txBox="1"/>
          <p:nvPr/>
        </p:nvSpPr>
        <p:spPr>
          <a:xfrm>
            <a:off x="152400" y="632720"/>
            <a:ext cx="16083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Exon 7 WT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  <p:sp>
        <p:nvSpPr>
          <p:cNvPr id="245" name="Google Shape;245;p21"/>
          <p:cNvSpPr/>
          <p:nvPr/>
        </p:nvSpPr>
        <p:spPr>
          <a:xfrm rot="-5400000">
            <a:off x="4505175" y="-651400"/>
            <a:ext cx="109500" cy="5135700"/>
          </a:xfrm>
          <a:prstGeom prst="leftBrace">
            <a:avLst>
              <a:gd fmla="val 50000" name="adj1"/>
              <a:gd fmla="val 50000" name="adj2"/>
            </a:avLst>
          </a:prstGeom>
          <a:noFill/>
          <a:ln cap="flat" cmpd="sng" w="9525">
            <a:solidFill>
              <a:schemeClr val="dk2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6" name="Google Shape;246;p21"/>
          <p:cNvSpPr txBox="1"/>
          <p:nvPr/>
        </p:nvSpPr>
        <p:spPr>
          <a:xfrm>
            <a:off x="3950175" y="197120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full length</a:t>
            </a:r>
            <a:endParaRPr sz="1000">
              <a:solidFill>
                <a:schemeClr val="dk2"/>
              </a:solidFill>
            </a:endParaRPr>
          </a:p>
        </p:txBody>
      </p:sp>
      <p:pic>
        <p:nvPicPr>
          <p:cNvPr id="247" name="Google Shape;247;p21" title="HGD26_TFP-F_03_06_2024_Vika_AG_Std_1_1_shorter_copy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398" y="2383150"/>
            <a:ext cx="3527560" cy="1216400"/>
          </a:xfrm>
          <a:prstGeom prst="rect">
            <a:avLst/>
          </a:prstGeom>
          <a:noFill/>
          <a:ln>
            <a:noFill/>
          </a:ln>
        </p:spPr>
      </p:pic>
      <p:sp>
        <p:nvSpPr>
          <p:cNvPr id="248" name="Google Shape;248;p21"/>
          <p:cNvSpPr txBox="1"/>
          <p:nvPr/>
        </p:nvSpPr>
        <p:spPr>
          <a:xfrm>
            <a:off x="1306413" y="3599550"/>
            <a:ext cx="12195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2"/>
                </a:solidFill>
              </a:rPr>
              <a:t>Exon 7 skipping</a:t>
            </a:r>
            <a:endParaRPr sz="1000">
              <a:solidFill>
                <a:schemeClr val="dk2"/>
              </a:solidFill>
            </a:endParaRPr>
          </a:p>
        </p:txBody>
      </p:sp>
      <p:sp>
        <p:nvSpPr>
          <p:cNvPr id="249" name="Google Shape;249;p21"/>
          <p:cNvSpPr txBox="1"/>
          <p:nvPr/>
        </p:nvSpPr>
        <p:spPr>
          <a:xfrm>
            <a:off x="152400" y="2277100"/>
            <a:ext cx="1948800" cy="161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ru" sz="1000">
                <a:solidFill>
                  <a:schemeClr val="lt1"/>
                </a:solidFill>
                <a:highlight>
                  <a:srgbClr val="666666"/>
                </a:highlight>
              </a:rPr>
              <a:t>c.469G&gt;T (p.Val157Phe)</a:t>
            </a:r>
            <a:endParaRPr b="1" sz="1000">
              <a:solidFill>
                <a:schemeClr val="lt1"/>
              </a:solidFill>
              <a:highlight>
                <a:srgbClr val="666666"/>
              </a:highlight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